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797675" cy="987425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D7D31"/>
    <a:srgbClr val="4472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1382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473367603042635"/>
          <c:y val="9.522777154238192E-2"/>
          <c:w val="0.89526632396957362"/>
          <c:h val="0.6288951480733462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EACOMPARE!$D$4:$D$20</c:f>
              <c:strCache>
                <c:ptCount val="17"/>
                <c:pt idx="0">
                  <c:v>developmental process</c:v>
                </c:pt>
                <c:pt idx="1">
                  <c:v>response to hormone stimulus</c:v>
                </c:pt>
                <c:pt idx="2">
                  <c:v>response to abiotic stimulus</c:v>
                </c:pt>
                <c:pt idx="3">
                  <c:v>cell wall organization or biogenesis</c:v>
                </c:pt>
                <c:pt idx="4">
                  <c:v>regulation of transcription</c:v>
                </c:pt>
                <c:pt idx="5">
                  <c:v>carbohydrate metabolic process</c:v>
                </c:pt>
                <c:pt idx="6">
                  <c:v>apoplast</c:v>
                </c:pt>
                <c:pt idx="7">
                  <c:v>cell wall</c:v>
                </c:pt>
                <c:pt idx="8">
                  <c:v>receptor activity</c:v>
                </c:pt>
                <c:pt idx="9">
                  <c:v>mitochondrion</c:v>
                </c:pt>
                <c:pt idx="10">
                  <c:v>intrinsic to membrane</c:v>
                </c:pt>
                <c:pt idx="11">
                  <c:v>chloroplast</c:v>
                </c:pt>
                <c:pt idx="12">
                  <c:v>electron transport chain</c:v>
                </c:pt>
                <c:pt idx="13">
                  <c:v>generation of metabolites and energy</c:v>
                </c:pt>
                <c:pt idx="14">
                  <c:v>signal transducer activity</c:v>
                </c:pt>
                <c:pt idx="15">
                  <c:v>photosynthetic membrane</c:v>
                </c:pt>
                <c:pt idx="16">
                  <c:v>membrane part</c:v>
                </c:pt>
              </c:strCache>
            </c:strRef>
          </c:cat>
          <c:val>
            <c:numRef>
              <c:f>SEACOMPARE!$F$4:$F$20</c:f>
              <c:numCache>
                <c:formatCode>General</c:formatCode>
                <c:ptCount val="17"/>
                <c:pt idx="0">
                  <c:v>13</c:v>
                </c:pt>
                <c:pt idx="1">
                  <c:v>12</c:v>
                </c:pt>
                <c:pt idx="2">
                  <c:v>13</c:v>
                </c:pt>
                <c:pt idx="3">
                  <c:v>13</c:v>
                </c:pt>
                <c:pt idx="4">
                  <c:v>36</c:v>
                </c:pt>
                <c:pt idx="5">
                  <c:v>38</c:v>
                </c:pt>
                <c:pt idx="6">
                  <c:v>12</c:v>
                </c:pt>
                <c:pt idx="7">
                  <c:v>10</c:v>
                </c:pt>
                <c:pt idx="8">
                  <c:v>7</c:v>
                </c:pt>
                <c:pt idx="9">
                  <c:v>75</c:v>
                </c:pt>
                <c:pt idx="10">
                  <c:v>38</c:v>
                </c:pt>
                <c:pt idx="11">
                  <c:v>5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C25-4F05-A920-6BF58AD498A7}"/>
            </c:ext>
          </c:extLst>
        </c:ser>
        <c:ser>
          <c:idx val="1"/>
          <c:order val="1"/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EACOMPARE!$D$4:$D$20</c:f>
              <c:strCache>
                <c:ptCount val="17"/>
                <c:pt idx="0">
                  <c:v>developmental process</c:v>
                </c:pt>
                <c:pt idx="1">
                  <c:v>response to hormone stimulus</c:v>
                </c:pt>
                <c:pt idx="2">
                  <c:v>response to abiotic stimulus</c:v>
                </c:pt>
                <c:pt idx="3">
                  <c:v>cell wall organization or biogenesis</c:v>
                </c:pt>
                <c:pt idx="4">
                  <c:v>regulation of transcription</c:v>
                </c:pt>
                <c:pt idx="5">
                  <c:v>carbohydrate metabolic process</c:v>
                </c:pt>
                <c:pt idx="6">
                  <c:v>apoplast</c:v>
                </c:pt>
                <c:pt idx="7">
                  <c:v>cell wall</c:v>
                </c:pt>
                <c:pt idx="8">
                  <c:v>receptor activity</c:v>
                </c:pt>
                <c:pt idx="9">
                  <c:v>mitochondrion</c:v>
                </c:pt>
                <c:pt idx="10">
                  <c:v>intrinsic to membrane</c:v>
                </c:pt>
                <c:pt idx="11">
                  <c:v>chloroplast</c:v>
                </c:pt>
                <c:pt idx="12">
                  <c:v>electron transport chain</c:v>
                </c:pt>
                <c:pt idx="13">
                  <c:v>generation of metabolites and energy</c:v>
                </c:pt>
                <c:pt idx="14">
                  <c:v>signal transducer activity</c:v>
                </c:pt>
                <c:pt idx="15">
                  <c:v>photosynthetic membrane</c:v>
                </c:pt>
                <c:pt idx="16">
                  <c:v>membrane part</c:v>
                </c:pt>
              </c:strCache>
            </c:strRef>
          </c:cat>
          <c:val>
            <c:numRef>
              <c:f>SEACOMPARE!$H$4:$H$20</c:f>
              <c:numCache>
                <c:formatCode>General</c:formatCode>
                <c:ptCount val="1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8</c:v>
                </c:pt>
                <c:pt idx="9">
                  <c:v>69</c:v>
                </c:pt>
                <c:pt idx="10">
                  <c:v>30</c:v>
                </c:pt>
                <c:pt idx="11">
                  <c:v>11</c:v>
                </c:pt>
                <c:pt idx="12">
                  <c:v>10</c:v>
                </c:pt>
                <c:pt idx="13">
                  <c:v>16</c:v>
                </c:pt>
                <c:pt idx="14">
                  <c:v>11</c:v>
                </c:pt>
                <c:pt idx="15">
                  <c:v>8</c:v>
                </c:pt>
                <c:pt idx="16">
                  <c:v>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C25-4F05-A920-6BF58AD498A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40999695"/>
        <c:axId val="848255935"/>
      </c:barChart>
      <c:catAx>
        <c:axId val="84099969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848255935"/>
        <c:crosses val="autoZero"/>
        <c:auto val="1"/>
        <c:lblAlgn val="ctr"/>
        <c:lblOffset val="100"/>
        <c:noMultiLvlLbl val="0"/>
      </c:catAx>
      <c:valAx>
        <c:axId val="84825593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84099969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A42D6-C58B-444E-AA11-D92C01C9A143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18305-D91A-4A99-ADE3-E40915F340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11451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A42D6-C58B-444E-AA11-D92C01C9A143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18305-D91A-4A99-ADE3-E40915F340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2113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A42D6-C58B-444E-AA11-D92C01C9A143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18305-D91A-4A99-ADE3-E40915F340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79852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A42D6-C58B-444E-AA11-D92C01C9A143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18305-D91A-4A99-ADE3-E40915F340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69745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A42D6-C58B-444E-AA11-D92C01C9A143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18305-D91A-4A99-ADE3-E40915F340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71551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A42D6-C58B-444E-AA11-D92C01C9A143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18305-D91A-4A99-ADE3-E40915F340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48081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A42D6-C58B-444E-AA11-D92C01C9A143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18305-D91A-4A99-ADE3-E40915F340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94042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A42D6-C58B-444E-AA11-D92C01C9A143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18305-D91A-4A99-ADE3-E40915F340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2056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A42D6-C58B-444E-AA11-D92C01C9A143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18305-D91A-4A99-ADE3-E40915F340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6277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A42D6-C58B-444E-AA11-D92C01C9A143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18305-D91A-4A99-ADE3-E40915F340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97206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A42D6-C58B-444E-AA11-D92C01C9A143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18305-D91A-4A99-ADE3-E40915F340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74201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6A42D6-C58B-444E-AA11-D92C01C9A143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318305-D91A-4A99-ADE3-E40915F340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25809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矩形 5">
            <a:extLst>
              <a:ext uri="{FF2B5EF4-FFF2-40B4-BE49-F238E27FC236}">
                <a16:creationId xmlns:a16="http://schemas.microsoft.com/office/drawing/2014/main" id="{C916BF55-751D-4790-94CF-3FB7F7340DF2}"/>
              </a:ext>
            </a:extLst>
          </p:cNvPr>
          <p:cNvSpPr/>
          <p:nvPr/>
        </p:nvSpPr>
        <p:spPr>
          <a:xfrm>
            <a:off x="6764784" y="1029810"/>
            <a:ext cx="115410" cy="71021"/>
          </a:xfrm>
          <a:prstGeom prst="rect">
            <a:avLst/>
          </a:prstGeom>
          <a:solidFill>
            <a:srgbClr val="4472C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8AF3DCC9-D071-45E3-A4BD-D99B5C908BCF}"/>
              </a:ext>
            </a:extLst>
          </p:cNvPr>
          <p:cNvSpPr/>
          <p:nvPr/>
        </p:nvSpPr>
        <p:spPr>
          <a:xfrm>
            <a:off x="6766261" y="1262111"/>
            <a:ext cx="115410" cy="71021"/>
          </a:xfrm>
          <a:prstGeom prst="rect">
            <a:avLst/>
          </a:prstGeom>
          <a:solidFill>
            <a:srgbClr val="ED7D3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2945CA94-A817-4FDB-A472-0FFEBAE9C18C}"/>
              </a:ext>
            </a:extLst>
          </p:cNvPr>
          <p:cNvSpPr txBox="1"/>
          <p:nvPr/>
        </p:nvSpPr>
        <p:spPr>
          <a:xfrm>
            <a:off x="6853557" y="949909"/>
            <a:ext cx="13671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Up-regulated genes</a:t>
            </a:r>
            <a:endParaRPr lang="zh-CN" altLang="en-US" sz="1000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D13F5614-AC18-4669-81C3-68545C237681}"/>
              </a:ext>
            </a:extLst>
          </p:cNvPr>
          <p:cNvSpPr txBox="1"/>
          <p:nvPr/>
        </p:nvSpPr>
        <p:spPr>
          <a:xfrm>
            <a:off x="6855037" y="1173333"/>
            <a:ext cx="13671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Down-regulated genes</a:t>
            </a:r>
            <a:endParaRPr lang="zh-CN" altLang="en-US" sz="1000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19CE32C1-E140-4FDE-BC94-C50EE750EC0C}"/>
              </a:ext>
            </a:extLst>
          </p:cNvPr>
          <p:cNvSpPr txBox="1"/>
          <p:nvPr/>
        </p:nvSpPr>
        <p:spPr>
          <a:xfrm rot="16200000">
            <a:off x="257455" y="1687354"/>
            <a:ext cx="21661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Number of genes</a:t>
            </a:r>
            <a:endParaRPr lang="zh-CN" altLang="en-US" sz="1100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13741A83-4596-4BB9-8C41-4EE8BE14896A}"/>
              </a:ext>
            </a:extLst>
          </p:cNvPr>
          <p:cNvSpPr txBox="1"/>
          <p:nvPr/>
        </p:nvSpPr>
        <p:spPr>
          <a:xfrm>
            <a:off x="1038687" y="5468647"/>
            <a:ext cx="7232939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altLang="zh-CN" sz="1400" kern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Gene Ontology (GO) enrichment analysis of the genes with up- and down-regulated expression levels exclusively in the 02428 seedlings that underwent the salt + melatonin treatment. The x-axis presents the GO function classifications and the y-axis presents the number of differentially expressed genes.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4" name="图表 13">
            <a:extLst>
              <a:ext uri="{FF2B5EF4-FFF2-40B4-BE49-F238E27FC236}">
                <a16:creationId xmlns:a16="http://schemas.microsoft.com/office/drawing/2014/main" id="{D7ED30A7-0FD0-487E-B318-EDD0B541DDC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84783830"/>
              </p:ext>
            </p:extLst>
          </p:nvPr>
        </p:nvGraphicFramePr>
        <p:xfrm>
          <a:off x="1038686" y="735082"/>
          <a:ext cx="7075503" cy="44494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40060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1</TotalTime>
  <Words>57</Words>
  <Application>Microsoft Office PowerPoint</Application>
  <PresentationFormat>全屏显示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BFu-2019</dc:creator>
  <cp:lastModifiedBy>BFu-2019</cp:lastModifiedBy>
  <cp:revision>8</cp:revision>
  <cp:lastPrinted>2020-08-20T02:06:21Z</cp:lastPrinted>
  <dcterms:created xsi:type="dcterms:W3CDTF">2020-08-20T01:23:02Z</dcterms:created>
  <dcterms:modified xsi:type="dcterms:W3CDTF">2020-10-16T08:31:34Z</dcterms:modified>
</cp:coreProperties>
</file>